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906000" cy="6858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5B6D7"/>
    <a:srgbClr val="DBD49C"/>
    <a:srgbClr val="FD9E8A"/>
    <a:srgbClr val="97C3E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389B388-A694-A54B-A6B1-3FAF32647C27}" v="14" dt="2023-05-28T09:17:20.40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574"/>
    <p:restoredTop sz="96327"/>
  </p:normalViewPr>
  <p:slideViewPr>
    <p:cSldViewPr snapToGrid="0" snapToObjects="1">
      <p:cViewPr varScale="1">
        <p:scale>
          <a:sx n="125" d="100"/>
          <a:sy n="125" d="100"/>
        </p:scale>
        <p:origin x="179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c Muller" userId="b47de76981260fd4" providerId="LiveId" clId="{A389B388-A694-A54B-A6B1-3FAF32647C27}"/>
    <pc:docChg chg="custSel modSld">
      <pc:chgData name="Marc Muller" userId="b47de76981260fd4" providerId="LiveId" clId="{A389B388-A694-A54B-A6B1-3FAF32647C27}" dt="2023-05-28T09:17:53.867" v="135" actId="14100"/>
      <pc:docMkLst>
        <pc:docMk/>
      </pc:docMkLst>
      <pc:sldChg chg="addSp delSp modSp mod">
        <pc:chgData name="Marc Muller" userId="b47de76981260fd4" providerId="LiveId" clId="{A389B388-A694-A54B-A6B1-3FAF32647C27}" dt="2023-05-28T09:17:53.867" v="135" actId="14100"/>
        <pc:sldMkLst>
          <pc:docMk/>
          <pc:sldMk cId="1969470929" sldId="256"/>
        </pc:sldMkLst>
        <pc:spChg chg="add">
          <ac:chgData name="Marc Muller" userId="b47de76981260fd4" providerId="LiveId" clId="{A389B388-A694-A54B-A6B1-3FAF32647C27}" dt="2023-05-13T16:20:38.611" v="2" actId="22"/>
          <ac:spMkLst>
            <pc:docMk/>
            <pc:sldMk cId="1969470929" sldId="256"/>
            <ac:spMk id="4" creationId="{ED90BE14-3F15-1240-F27C-9F183E743CFF}"/>
          </ac:spMkLst>
        </pc:spChg>
        <pc:spChg chg="add mod">
          <ac:chgData name="Marc Muller" userId="b47de76981260fd4" providerId="LiveId" clId="{A389B388-A694-A54B-A6B1-3FAF32647C27}" dt="2023-05-13T16:21:14.964" v="4" actId="1076"/>
          <ac:spMkLst>
            <pc:docMk/>
            <pc:sldMk cId="1969470929" sldId="256"/>
            <ac:spMk id="6" creationId="{1DC1C8EB-4B64-F174-65FB-C0214A61F46A}"/>
          </ac:spMkLst>
        </pc:spChg>
        <pc:spChg chg="mod">
          <ac:chgData name="Marc Muller" userId="b47de76981260fd4" providerId="LiveId" clId="{A389B388-A694-A54B-A6B1-3FAF32647C27}" dt="2023-05-13T16:30:59.580" v="63" actId="164"/>
          <ac:spMkLst>
            <pc:docMk/>
            <pc:sldMk cId="1969470929" sldId="256"/>
            <ac:spMk id="10" creationId="{6D34C78A-1848-D24D-42E0-926B8C3D8EA9}"/>
          </ac:spMkLst>
        </pc:spChg>
        <pc:spChg chg="mod">
          <ac:chgData name="Marc Muller" userId="b47de76981260fd4" providerId="LiveId" clId="{A389B388-A694-A54B-A6B1-3FAF32647C27}" dt="2023-05-13T16:31:44.613" v="118" actId="465"/>
          <ac:spMkLst>
            <pc:docMk/>
            <pc:sldMk cId="1969470929" sldId="256"/>
            <ac:spMk id="11" creationId="{248CA112-AE56-327F-A713-1D5C073E20E6}"/>
          </ac:spMkLst>
        </pc:spChg>
        <pc:spChg chg="mod">
          <ac:chgData name="Marc Muller" userId="b47de76981260fd4" providerId="LiveId" clId="{A389B388-A694-A54B-A6B1-3FAF32647C27}" dt="2023-05-13T16:31:44.613" v="118" actId="465"/>
          <ac:spMkLst>
            <pc:docMk/>
            <pc:sldMk cId="1969470929" sldId="256"/>
            <ac:spMk id="12" creationId="{D971E38E-C87B-E9BD-7C61-9E89204006F5}"/>
          </ac:spMkLst>
        </pc:spChg>
        <pc:spChg chg="mod">
          <ac:chgData name="Marc Muller" userId="b47de76981260fd4" providerId="LiveId" clId="{A389B388-A694-A54B-A6B1-3FAF32647C27}" dt="2023-05-13T16:30:13.519" v="57" actId="164"/>
          <ac:spMkLst>
            <pc:docMk/>
            <pc:sldMk cId="1969470929" sldId="256"/>
            <ac:spMk id="13" creationId="{2FF202B9-E7AA-8854-2D88-2F147C29E112}"/>
          </ac:spMkLst>
        </pc:spChg>
        <pc:spChg chg="mod">
          <ac:chgData name="Marc Muller" userId="b47de76981260fd4" providerId="LiveId" clId="{A389B388-A694-A54B-A6B1-3FAF32647C27}" dt="2023-05-13T16:23:12.611" v="7"/>
          <ac:spMkLst>
            <pc:docMk/>
            <pc:sldMk cId="1969470929" sldId="256"/>
            <ac:spMk id="16" creationId="{538496CA-3BAE-43F8-EE10-F03DB5B3AA0D}"/>
          </ac:spMkLst>
        </pc:spChg>
        <pc:spChg chg="mod">
          <ac:chgData name="Marc Muller" userId="b47de76981260fd4" providerId="LiveId" clId="{A389B388-A694-A54B-A6B1-3FAF32647C27}" dt="2023-05-13T16:23:34.527" v="10" actId="20577"/>
          <ac:spMkLst>
            <pc:docMk/>
            <pc:sldMk cId="1969470929" sldId="256"/>
            <ac:spMk id="17" creationId="{B40390A7-32AB-3FC1-9F58-81814BF27B3E}"/>
          </ac:spMkLst>
        </pc:spChg>
        <pc:spChg chg="mod">
          <ac:chgData name="Marc Muller" userId="b47de76981260fd4" providerId="LiveId" clId="{A389B388-A694-A54B-A6B1-3FAF32647C27}" dt="2023-05-13T16:23:40.714" v="12" actId="20577"/>
          <ac:spMkLst>
            <pc:docMk/>
            <pc:sldMk cId="1969470929" sldId="256"/>
            <ac:spMk id="18" creationId="{3FDEFF37-369C-F897-DCAB-266AB1D751AA}"/>
          </ac:spMkLst>
        </pc:spChg>
        <pc:spChg chg="add mod">
          <ac:chgData name="Marc Muller" userId="b47de76981260fd4" providerId="LiveId" clId="{A389B388-A694-A54B-A6B1-3FAF32647C27}" dt="2023-05-13T16:30:13.519" v="57" actId="164"/>
          <ac:spMkLst>
            <pc:docMk/>
            <pc:sldMk cId="1969470929" sldId="256"/>
            <ac:spMk id="19" creationId="{69D0B974-7354-DA0C-7935-F4ADD3179DB0}"/>
          </ac:spMkLst>
        </pc:spChg>
        <pc:spChg chg="add mod">
          <ac:chgData name="Marc Muller" userId="b47de76981260fd4" providerId="LiveId" clId="{A389B388-A694-A54B-A6B1-3FAF32647C27}" dt="2023-05-13T16:31:44.613" v="118" actId="465"/>
          <ac:spMkLst>
            <pc:docMk/>
            <pc:sldMk cId="1969470929" sldId="256"/>
            <ac:spMk id="20" creationId="{674137F7-97C6-AE6C-FD89-A0174C0E1261}"/>
          </ac:spMkLst>
        </pc:spChg>
        <pc:spChg chg="add mod">
          <ac:chgData name="Marc Muller" userId="b47de76981260fd4" providerId="LiveId" clId="{A389B388-A694-A54B-A6B1-3FAF32647C27}" dt="2023-05-13T16:30:59.580" v="63" actId="164"/>
          <ac:spMkLst>
            <pc:docMk/>
            <pc:sldMk cId="1969470929" sldId="256"/>
            <ac:spMk id="21" creationId="{0727A6C5-2E4A-B458-D1C5-A0391C2F1AEB}"/>
          </ac:spMkLst>
        </pc:spChg>
        <pc:spChg chg="add mod">
          <ac:chgData name="Marc Muller" userId="b47de76981260fd4" providerId="LiveId" clId="{A389B388-A694-A54B-A6B1-3FAF32647C27}" dt="2023-05-13T16:31:44.613" v="118" actId="465"/>
          <ac:spMkLst>
            <pc:docMk/>
            <pc:sldMk cId="1969470929" sldId="256"/>
            <ac:spMk id="22" creationId="{44C7ADD0-A487-1C38-CC2E-29BBB6EB192B}"/>
          </ac:spMkLst>
        </pc:spChg>
        <pc:grpChg chg="add mod">
          <ac:chgData name="Marc Muller" userId="b47de76981260fd4" providerId="LiveId" clId="{A389B388-A694-A54B-A6B1-3FAF32647C27}" dt="2023-05-13T16:32:38.893" v="126" actId="1076"/>
          <ac:grpSpMkLst>
            <pc:docMk/>
            <pc:sldMk cId="1969470929" sldId="256"/>
            <ac:grpSpMk id="8" creationId="{0826D6AF-EFAE-F4C7-8DE8-6BF9530FF843}"/>
          </ac:grpSpMkLst>
        </pc:grpChg>
        <pc:grpChg chg="mod">
          <ac:chgData name="Marc Muller" userId="b47de76981260fd4" providerId="LiveId" clId="{A389B388-A694-A54B-A6B1-3FAF32647C27}" dt="2023-05-13T16:23:12.611" v="7"/>
          <ac:grpSpMkLst>
            <pc:docMk/>
            <pc:sldMk cId="1969470929" sldId="256"/>
            <ac:grpSpMk id="15" creationId="{90E685F9-DB4B-41BF-8127-153C8D4AC162}"/>
          </ac:grpSpMkLst>
        </pc:grpChg>
        <pc:grpChg chg="add mod">
          <ac:chgData name="Marc Muller" userId="b47de76981260fd4" providerId="LiveId" clId="{A389B388-A694-A54B-A6B1-3FAF32647C27}" dt="2023-05-13T16:31:56.070" v="119" actId="164"/>
          <ac:grpSpMkLst>
            <pc:docMk/>
            <pc:sldMk cId="1969470929" sldId="256"/>
            <ac:grpSpMk id="25" creationId="{4443A5D9-0313-01C3-4269-2BD2D67AC004}"/>
          </ac:grpSpMkLst>
        </pc:grpChg>
        <pc:grpChg chg="add mod">
          <ac:chgData name="Marc Muller" userId="b47de76981260fd4" providerId="LiveId" clId="{A389B388-A694-A54B-A6B1-3FAF32647C27}" dt="2023-05-13T16:31:56.070" v="119" actId="164"/>
          <ac:grpSpMkLst>
            <pc:docMk/>
            <pc:sldMk cId="1969470929" sldId="256"/>
            <ac:grpSpMk id="26" creationId="{E482C497-6C12-006A-EFDC-135B09D86F60}"/>
          </ac:grpSpMkLst>
        </pc:grpChg>
        <pc:grpChg chg="add mod">
          <ac:chgData name="Marc Muller" userId="b47de76981260fd4" providerId="LiveId" clId="{A389B388-A694-A54B-A6B1-3FAF32647C27}" dt="2023-05-13T16:31:56.070" v="119" actId="164"/>
          <ac:grpSpMkLst>
            <pc:docMk/>
            <pc:sldMk cId="1969470929" sldId="256"/>
            <ac:grpSpMk id="27" creationId="{C589EC8F-0E1A-C654-75A5-BC64128E119A}"/>
          </ac:grpSpMkLst>
        </pc:grpChg>
        <pc:grpChg chg="add mod">
          <ac:chgData name="Marc Muller" userId="b47de76981260fd4" providerId="LiveId" clId="{A389B388-A694-A54B-A6B1-3FAF32647C27}" dt="2023-05-13T16:31:56.070" v="119" actId="164"/>
          <ac:grpSpMkLst>
            <pc:docMk/>
            <pc:sldMk cId="1969470929" sldId="256"/>
            <ac:grpSpMk id="28" creationId="{8AAA7A97-F706-F7C0-320A-177349ABC806}"/>
          </ac:grpSpMkLst>
        </pc:grpChg>
        <pc:grpChg chg="add mod">
          <ac:chgData name="Marc Muller" userId="b47de76981260fd4" providerId="LiveId" clId="{A389B388-A694-A54B-A6B1-3FAF32647C27}" dt="2023-05-13T16:32:25.161" v="125" actId="1076"/>
          <ac:grpSpMkLst>
            <pc:docMk/>
            <pc:sldMk cId="1969470929" sldId="256"/>
            <ac:grpSpMk id="29" creationId="{E871AE4F-F19D-0797-F380-2D8A8C12423F}"/>
          </ac:grpSpMkLst>
        </pc:grpChg>
        <pc:picChg chg="add mod modCrop">
          <ac:chgData name="Marc Muller" userId="b47de76981260fd4" providerId="LiveId" clId="{A389B388-A694-A54B-A6B1-3FAF32647C27}" dt="2023-05-28T09:17:53.867" v="135" actId="14100"/>
          <ac:picMkLst>
            <pc:docMk/>
            <pc:sldMk cId="1969470929" sldId="256"/>
            <ac:picMk id="3" creationId="{74815FE1-EC74-19FD-6AE7-50E50208033F}"/>
          </ac:picMkLst>
        </pc:picChg>
        <pc:picChg chg="del">
          <ac:chgData name="Marc Muller" userId="b47de76981260fd4" providerId="LiveId" clId="{A389B388-A694-A54B-A6B1-3FAF32647C27}" dt="2023-05-13T16:28:59.980" v="47" actId="478"/>
          <ac:picMkLst>
            <pc:docMk/>
            <pc:sldMk cId="1969470929" sldId="256"/>
            <ac:picMk id="3" creationId="{A1BC4F9D-DE77-E4B1-E830-85FED814E616}"/>
          </ac:picMkLst>
        </pc:picChg>
        <pc:picChg chg="del mod">
          <ac:chgData name="Marc Muller" userId="b47de76981260fd4" providerId="LiveId" clId="{A389B388-A694-A54B-A6B1-3FAF32647C27}" dt="2023-05-13T16:23:46.328" v="13" actId="478"/>
          <ac:picMkLst>
            <pc:docMk/>
            <pc:sldMk cId="1969470929" sldId="256"/>
            <ac:picMk id="7" creationId="{81CE3F5F-7BAB-9225-1471-4B7D50790250}"/>
          </ac:picMkLst>
        </pc:picChg>
        <pc:picChg chg="del mod">
          <ac:chgData name="Marc Muller" userId="b47de76981260fd4" providerId="LiveId" clId="{A389B388-A694-A54B-A6B1-3FAF32647C27}" dt="2023-05-13T16:32:03.724" v="121" actId="478"/>
          <ac:picMkLst>
            <pc:docMk/>
            <pc:sldMk cId="1969470929" sldId="256"/>
            <ac:picMk id="9" creationId="{A2D582A0-AC4F-C283-2510-ECB8DA631704}"/>
          </ac:picMkLst>
        </pc:picChg>
        <pc:picChg chg="mod">
          <ac:chgData name="Marc Muller" userId="b47de76981260fd4" providerId="LiveId" clId="{A389B388-A694-A54B-A6B1-3FAF32647C27}" dt="2023-05-13T16:23:12.611" v="7"/>
          <ac:picMkLst>
            <pc:docMk/>
            <pc:sldMk cId="1969470929" sldId="256"/>
            <ac:picMk id="14" creationId="{3C4AA3C0-A8FE-B400-8BC3-2E51A2089EC2}"/>
          </ac:picMkLst>
        </pc:picChg>
        <pc:picChg chg="add del mod modCrop">
          <ac:chgData name="Marc Muller" userId="b47de76981260fd4" providerId="LiveId" clId="{A389B388-A694-A54B-A6B1-3FAF32647C27}" dt="2023-05-28T09:17:10.038" v="127" actId="478"/>
          <ac:picMkLst>
            <pc:docMk/>
            <pc:sldMk cId="1969470929" sldId="256"/>
            <ac:picMk id="24" creationId="{A3AA6723-FB6A-F0B7-4119-A10472F4A02E}"/>
          </ac:picMkLst>
        </pc:picChg>
        <pc:picChg chg="add del">
          <ac:chgData name="Marc Muller" userId="b47de76981260fd4" providerId="LiveId" clId="{A389B388-A694-A54B-A6B1-3FAF32647C27}" dt="2023-05-13T16:22:19.816" v="6" actId="478"/>
          <ac:picMkLst>
            <pc:docMk/>
            <pc:sldMk cId="1969470929" sldId="256"/>
            <ac:picMk id="1026" creationId="{B13F08F5-C105-4697-8D1F-606FE5606B3C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600"/>
            </a:lvl1pPr>
            <a:lvl2pPr marL="495285" indent="0" algn="ctr">
              <a:buNone/>
              <a:defRPr sz="2167"/>
            </a:lvl2pPr>
            <a:lvl3pPr marL="990570" indent="0" algn="ctr">
              <a:buNone/>
              <a:defRPr sz="1950"/>
            </a:lvl3pPr>
            <a:lvl4pPr marL="1485854" indent="0" algn="ctr">
              <a:buNone/>
              <a:defRPr sz="1733"/>
            </a:lvl4pPr>
            <a:lvl5pPr marL="1981139" indent="0" algn="ctr">
              <a:buNone/>
              <a:defRPr sz="1733"/>
            </a:lvl5pPr>
            <a:lvl6pPr marL="2476424" indent="0" algn="ctr">
              <a:buNone/>
              <a:defRPr sz="1733"/>
            </a:lvl6pPr>
            <a:lvl7pPr marL="2971709" indent="0" algn="ctr">
              <a:buNone/>
              <a:defRPr sz="1733"/>
            </a:lvl7pPr>
            <a:lvl8pPr marL="3466993" indent="0" algn="ctr">
              <a:buNone/>
              <a:defRPr sz="1733"/>
            </a:lvl8pPr>
            <a:lvl9pPr marL="3962278" indent="0" algn="ctr">
              <a:buNone/>
              <a:defRPr sz="1733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410A-B8A4-7043-B56C-9E9FCB86595B}" type="datetimeFigureOut">
              <a:rPr lang="en-US" smtClean="0"/>
              <a:t>5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1B309-2770-B54B-A0BE-F9F7F5C51FB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34691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410A-B8A4-7043-B56C-9E9FCB86595B}" type="datetimeFigureOut">
              <a:rPr lang="en-US" smtClean="0"/>
              <a:t>5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1B309-2770-B54B-A0BE-F9F7F5C51FB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42949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410A-B8A4-7043-B56C-9E9FCB86595B}" type="datetimeFigureOut">
              <a:rPr lang="en-US" smtClean="0"/>
              <a:t>5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1B309-2770-B54B-A0BE-F9F7F5C51FB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62195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410A-B8A4-7043-B56C-9E9FCB86595B}" type="datetimeFigureOut">
              <a:rPr lang="en-US" smtClean="0"/>
              <a:t>5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1B309-2770-B54B-A0BE-F9F7F5C51FB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71814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600">
                <a:solidFill>
                  <a:schemeClr val="tx1"/>
                </a:solidFill>
              </a:defRPr>
            </a:lvl1pPr>
            <a:lvl2pPr marL="495285" indent="0">
              <a:buNone/>
              <a:defRPr sz="2167">
                <a:solidFill>
                  <a:schemeClr val="tx1">
                    <a:tint val="75000"/>
                  </a:schemeClr>
                </a:solidFill>
              </a:defRPr>
            </a:lvl2pPr>
            <a:lvl3pPr marL="990570" indent="0">
              <a:buNone/>
              <a:defRPr sz="1950">
                <a:solidFill>
                  <a:schemeClr val="tx1">
                    <a:tint val="75000"/>
                  </a:schemeClr>
                </a:solidFill>
              </a:defRPr>
            </a:lvl3pPr>
            <a:lvl4pPr marL="1485854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4pPr>
            <a:lvl5pPr marL="1981139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5pPr>
            <a:lvl6pPr marL="2476424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6pPr>
            <a:lvl7pPr marL="2971709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7pPr>
            <a:lvl8pPr marL="3466993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8pPr>
            <a:lvl9pPr marL="3962278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410A-B8A4-7043-B56C-9E9FCB86595B}" type="datetimeFigureOut">
              <a:rPr lang="en-US" smtClean="0"/>
              <a:t>5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1B309-2770-B54B-A0BE-F9F7F5C51FB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24700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410A-B8A4-7043-B56C-9E9FCB86595B}" type="datetimeFigureOut">
              <a:rPr lang="en-US" smtClean="0"/>
              <a:t>5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1B309-2770-B54B-A0BE-F9F7F5C51FB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68899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365127"/>
            <a:ext cx="8543925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4"/>
            <a:ext cx="4190702" cy="823912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6"/>
            <a:ext cx="4190702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4" y="1681164"/>
            <a:ext cx="4211340" cy="823912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4" y="2505076"/>
            <a:ext cx="4211340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410A-B8A4-7043-B56C-9E9FCB86595B}" type="datetimeFigureOut">
              <a:rPr lang="en-US" smtClean="0"/>
              <a:t>5/28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1B309-2770-B54B-A0BE-F9F7F5C51FB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35415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410A-B8A4-7043-B56C-9E9FCB86595B}" type="datetimeFigureOut">
              <a:rPr lang="en-US" smtClean="0"/>
              <a:t>5/28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1B309-2770-B54B-A0BE-F9F7F5C51FB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5633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410A-B8A4-7043-B56C-9E9FCB86595B}" type="datetimeFigureOut">
              <a:rPr lang="en-US" smtClean="0"/>
              <a:t>5/28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1B309-2770-B54B-A0BE-F9F7F5C51FB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049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3467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1" y="987427"/>
            <a:ext cx="5014913" cy="4873625"/>
          </a:xfrm>
        </p:spPr>
        <p:txBody>
          <a:bodyPr/>
          <a:lstStyle>
            <a:lvl1pPr>
              <a:defRPr sz="3467"/>
            </a:lvl1pPr>
            <a:lvl2pPr>
              <a:defRPr sz="3033"/>
            </a:lvl2pPr>
            <a:lvl3pPr>
              <a:defRPr sz="2600"/>
            </a:lvl3pPr>
            <a:lvl4pPr>
              <a:defRPr sz="2167"/>
            </a:lvl4pPr>
            <a:lvl5pPr>
              <a:defRPr sz="2167"/>
            </a:lvl5pPr>
            <a:lvl6pPr>
              <a:defRPr sz="2167"/>
            </a:lvl6pPr>
            <a:lvl7pPr>
              <a:defRPr sz="2167"/>
            </a:lvl7pPr>
            <a:lvl8pPr>
              <a:defRPr sz="2167"/>
            </a:lvl8pPr>
            <a:lvl9pPr>
              <a:defRPr sz="2167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733"/>
            </a:lvl1pPr>
            <a:lvl2pPr marL="495285" indent="0">
              <a:buNone/>
              <a:defRPr sz="1517"/>
            </a:lvl2pPr>
            <a:lvl3pPr marL="990570" indent="0">
              <a:buNone/>
              <a:defRPr sz="1300"/>
            </a:lvl3pPr>
            <a:lvl4pPr marL="1485854" indent="0">
              <a:buNone/>
              <a:defRPr sz="1083"/>
            </a:lvl4pPr>
            <a:lvl5pPr marL="1981139" indent="0">
              <a:buNone/>
              <a:defRPr sz="1083"/>
            </a:lvl5pPr>
            <a:lvl6pPr marL="2476424" indent="0">
              <a:buNone/>
              <a:defRPr sz="1083"/>
            </a:lvl6pPr>
            <a:lvl7pPr marL="2971709" indent="0">
              <a:buNone/>
              <a:defRPr sz="1083"/>
            </a:lvl7pPr>
            <a:lvl8pPr marL="3466993" indent="0">
              <a:buNone/>
              <a:defRPr sz="1083"/>
            </a:lvl8pPr>
            <a:lvl9pPr marL="3962278" indent="0">
              <a:buNone/>
              <a:defRPr sz="1083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410A-B8A4-7043-B56C-9E9FCB86595B}" type="datetimeFigureOut">
              <a:rPr lang="en-US" smtClean="0"/>
              <a:t>5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1B309-2770-B54B-A0BE-F9F7F5C51FB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37051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3467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1" y="987427"/>
            <a:ext cx="5014913" cy="4873625"/>
          </a:xfrm>
        </p:spPr>
        <p:txBody>
          <a:bodyPr anchor="t"/>
          <a:lstStyle>
            <a:lvl1pPr marL="0" indent="0">
              <a:buNone/>
              <a:defRPr sz="3467"/>
            </a:lvl1pPr>
            <a:lvl2pPr marL="495285" indent="0">
              <a:buNone/>
              <a:defRPr sz="3033"/>
            </a:lvl2pPr>
            <a:lvl3pPr marL="990570" indent="0">
              <a:buNone/>
              <a:defRPr sz="2600"/>
            </a:lvl3pPr>
            <a:lvl4pPr marL="1485854" indent="0">
              <a:buNone/>
              <a:defRPr sz="2167"/>
            </a:lvl4pPr>
            <a:lvl5pPr marL="1981139" indent="0">
              <a:buNone/>
              <a:defRPr sz="2167"/>
            </a:lvl5pPr>
            <a:lvl6pPr marL="2476424" indent="0">
              <a:buNone/>
              <a:defRPr sz="2167"/>
            </a:lvl6pPr>
            <a:lvl7pPr marL="2971709" indent="0">
              <a:buNone/>
              <a:defRPr sz="2167"/>
            </a:lvl7pPr>
            <a:lvl8pPr marL="3466993" indent="0">
              <a:buNone/>
              <a:defRPr sz="2167"/>
            </a:lvl8pPr>
            <a:lvl9pPr marL="3962278" indent="0">
              <a:buNone/>
              <a:defRPr sz="2167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733"/>
            </a:lvl1pPr>
            <a:lvl2pPr marL="495285" indent="0">
              <a:buNone/>
              <a:defRPr sz="1517"/>
            </a:lvl2pPr>
            <a:lvl3pPr marL="990570" indent="0">
              <a:buNone/>
              <a:defRPr sz="1300"/>
            </a:lvl3pPr>
            <a:lvl4pPr marL="1485854" indent="0">
              <a:buNone/>
              <a:defRPr sz="1083"/>
            </a:lvl4pPr>
            <a:lvl5pPr marL="1981139" indent="0">
              <a:buNone/>
              <a:defRPr sz="1083"/>
            </a:lvl5pPr>
            <a:lvl6pPr marL="2476424" indent="0">
              <a:buNone/>
              <a:defRPr sz="1083"/>
            </a:lvl6pPr>
            <a:lvl7pPr marL="2971709" indent="0">
              <a:buNone/>
              <a:defRPr sz="1083"/>
            </a:lvl7pPr>
            <a:lvl8pPr marL="3466993" indent="0">
              <a:buNone/>
              <a:defRPr sz="1083"/>
            </a:lvl8pPr>
            <a:lvl9pPr marL="3962278" indent="0">
              <a:buNone/>
              <a:defRPr sz="1083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410A-B8A4-7043-B56C-9E9FCB86595B}" type="datetimeFigureOut">
              <a:rPr lang="en-US" smtClean="0"/>
              <a:t>5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1B309-2770-B54B-A0BE-F9F7F5C51FB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8376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9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9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6D410A-B8A4-7043-B56C-9E9FCB86595B}" type="datetimeFigureOut">
              <a:rPr lang="en-US" smtClean="0"/>
              <a:t>5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4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B1B309-2770-B54B-A0BE-F9F7F5C51FB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24133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90570" rtl="0" eaLnBrk="1" latinLnBrk="0" hangingPunct="1">
        <a:lnSpc>
          <a:spcPct val="90000"/>
        </a:lnSpc>
        <a:spcBef>
          <a:spcPct val="0"/>
        </a:spcBef>
        <a:buNone/>
        <a:defRPr sz="47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7642" indent="-247642" algn="l" defTabSz="99057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033" kern="1200">
          <a:solidFill>
            <a:schemeClr val="tx1"/>
          </a:solidFill>
          <a:latin typeface="+mn-lt"/>
          <a:ea typeface="+mn-ea"/>
          <a:cs typeface="+mn-cs"/>
        </a:defRPr>
      </a:lvl1pPr>
      <a:lvl2pPr marL="742927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238212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2167" kern="1200">
          <a:solidFill>
            <a:schemeClr val="tx1"/>
          </a:solidFill>
          <a:latin typeface="+mn-lt"/>
          <a:ea typeface="+mn-ea"/>
          <a:cs typeface="+mn-cs"/>
        </a:defRPr>
      </a:lvl3pPr>
      <a:lvl4pPr marL="1733497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2228781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724066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3219351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714636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4209920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1pPr>
      <a:lvl2pPr marL="495285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2pPr>
      <a:lvl3pPr marL="990570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3pPr>
      <a:lvl4pPr marL="1485854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1981139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476424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09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466993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3962278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ED90BE14-3F15-1240-F27C-9F183E743CFF}"/>
              </a:ext>
            </a:extLst>
          </p:cNvPr>
          <p:cNvSpPr txBox="1"/>
          <p:nvPr/>
        </p:nvSpPr>
        <p:spPr>
          <a:xfrm>
            <a:off x="2478121" y="3244334"/>
            <a:ext cx="495624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BE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 </a:t>
            </a:r>
            <a:endParaRPr lang="en-US" dirty="0"/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1DC1C8EB-4B64-F174-65FB-C0214A61F46A}"/>
              </a:ext>
            </a:extLst>
          </p:cNvPr>
          <p:cNvSpPr txBox="1"/>
          <p:nvPr/>
        </p:nvSpPr>
        <p:spPr>
          <a:xfrm>
            <a:off x="2183330" y="3481152"/>
            <a:ext cx="495624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BE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 </a:t>
            </a:r>
            <a:endParaRPr lang="en-US" dirty="0"/>
          </a:p>
        </p:txBody>
      </p:sp>
      <p:grpSp>
        <p:nvGrpSpPr>
          <p:cNvPr id="8" name="Groupe 7">
            <a:extLst>
              <a:ext uri="{FF2B5EF4-FFF2-40B4-BE49-F238E27FC236}">
                <a16:creationId xmlns:a16="http://schemas.microsoft.com/office/drawing/2014/main" id="{0826D6AF-EFAE-F4C7-8DE8-6BF9530FF843}"/>
              </a:ext>
            </a:extLst>
          </p:cNvPr>
          <p:cNvGrpSpPr/>
          <p:nvPr/>
        </p:nvGrpSpPr>
        <p:grpSpPr>
          <a:xfrm>
            <a:off x="6100106" y="5512720"/>
            <a:ext cx="2470589" cy="1036238"/>
            <a:chOff x="550517" y="5665987"/>
            <a:chExt cx="2470589" cy="1036238"/>
          </a:xfrm>
        </p:grpSpPr>
        <p:pic>
          <p:nvPicPr>
            <p:cNvPr id="14" name="Image 13">
              <a:extLst>
                <a:ext uri="{FF2B5EF4-FFF2-40B4-BE49-F238E27FC236}">
                  <a16:creationId xmlns:a16="http://schemas.microsoft.com/office/drawing/2014/main" id="{3C4AA3C0-A8FE-B400-8BC3-2E51A2089EC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50517" y="5665987"/>
              <a:ext cx="2470589" cy="903778"/>
            </a:xfrm>
            <a:prstGeom prst="rect">
              <a:avLst/>
            </a:prstGeom>
          </p:spPr>
        </p:pic>
        <p:grpSp>
          <p:nvGrpSpPr>
            <p:cNvPr id="15" name="Groupe 14">
              <a:extLst>
                <a:ext uri="{FF2B5EF4-FFF2-40B4-BE49-F238E27FC236}">
                  <a16:creationId xmlns:a16="http://schemas.microsoft.com/office/drawing/2014/main" id="{90E685F9-DB4B-41BF-8127-153C8D4AC162}"/>
                </a:ext>
              </a:extLst>
            </p:cNvPr>
            <p:cNvGrpSpPr/>
            <p:nvPr/>
          </p:nvGrpSpPr>
          <p:grpSpPr>
            <a:xfrm>
              <a:off x="550517" y="6502170"/>
              <a:ext cx="2470589" cy="200055"/>
              <a:chOff x="550517" y="6563670"/>
              <a:chExt cx="2470589" cy="200055"/>
            </a:xfrm>
          </p:grpSpPr>
          <p:sp>
            <p:nvSpPr>
              <p:cNvPr id="16" name="ZoneTexte 15">
                <a:extLst>
                  <a:ext uri="{FF2B5EF4-FFF2-40B4-BE49-F238E27FC236}">
                    <a16:creationId xmlns:a16="http://schemas.microsoft.com/office/drawing/2014/main" id="{538496CA-3BAE-43F8-EE10-F03DB5B3AA0D}"/>
                  </a:ext>
                </a:extLst>
              </p:cNvPr>
              <p:cNvSpPr txBox="1"/>
              <p:nvPr/>
            </p:nvSpPr>
            <p:spPr>
              <a:xfrm>
                <a:off x="550517" y="6563670"/>
                <a:ext cx="2470589" cy="20005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/>
                  <a:t>log2(fold-change)</a:t>
                </a:r>
              </a:p>
            </p:txBody>
          </p:sp>
          <p:sp>
            <p:nvSpPr>
              <p:cNvPr id="17" name="ZoneTexte 16">
                <a:extLst>
                  <a:ext uri="{FF2B5EF4-FFF2-40B4-BE49-F238E27FC236}">
                    <a16:creationId xmlns:a16="http://schemas.microsoft.com/office/drawing/2014/main" id="{B40390A7-32AB-3FC1-9F58-81814BF27B3E}"/>
                  </a:ext>
                </a:extLst>
              </p:cNvPr>
              <p:cNvSpPr txBox="1"/>
              <p:nvPr/>
            </p:nvSpPr>
            <p:spPr>
              <a:xfrm>
                <a:off x="550517" y="6563670"/>
                <a:ext cx="352971" cy="20005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/>
                  <a:t>-4.0</a:t>
                </a:r>
              </a:p>
            </p:txBody>
          </p:sp>
          <p:sp>
            <p:nvSpPr>
              <p:cNvPr id="18" name="ZoneTexte 17">
                <a:extLst>
                  <a:ext uri="{FF2B5EF4-FFF2-40B4-BE49-F238E27FC236}">
                    <a16:creationId xmlns:a16="http://schemas.microsoft.com/office/drawing/2014/main" id="{3FDEFF37-369C-F897-DCAB-266AB1D751AA}"/>
                  </a:ext>
                </a:extLst>
              </p:cNvPr>
              <p:cNvSpPr txBox="1"/>
              <p:nvPr/>
            </p:nvSpPr>
            <p:spPr>
              <a:xfrm>
                <a:off x="2718597" y="6563670"/>
                <a:ext cx="302509" cy="20005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/>
                  <a:t>4.0</a:t>
                </a:r>
              </a:p>
            </p:txBody>
          </p:sp>
        </p:grpSp>
      </p:grpSp>
      <p:grpSp>
        <p:nvGrpSpPr>
          <p:cNvPr id="29" name="Groupe 28">
            <a:extLst>
              <a:ext uri="{FF2B5EF4-FFF2-40B4-BE49-F238E27FC236}">
                <a16:creationId xmlns:a16="http://schemas.microsoft.com/office/drawing/2014/main" id="{E871AE4F-F19D-0797-F380-2D8A8C12423F}"/>
              </a:ext>
            </a:extLst>
          </p:cNvPr>
          <p:cNvGrpSpPr/>
          <p:nvPr/>
        </p:nvGrpSpPr>
        <p:grpSpPr>
          <a:xfrm>
            <a:off x="1356852" y="5743925"/>
            <a:ext cx="2408981" cy="722243"/>
            <a:chOff x="502080" y="5886940"/>
            <a:chExt cx="2408981" cy="722243"/>
          </a:xfrm>
        </p:grpSpPr>
        <p:grpSp>
          <p:nvGrpSpPr>
            <p:cNvPr id="25" name="Groupe 24">
              <a:extLst>
                <a:ext uri="{FF2B5EF4-FFF2-40B4-BE49-F238E27FC236}">
                  <a16:creationId xmlns:a16="http://schemas.microsoft.com/office/drawing/2014/main" id="{4443A5D9-0313-01C3-4269-2BD2D67AC004}"/>
                </a:ext>
              </a:extLst>
            </p:cNvPr>
            <p:cNvGrpSpPr/>
            <p:nvPr/>
          </p:nvGrpSpPr>
          <p:grpSpPr>
            <a:xfrm>
              <a:off x="502080" y="5886940"/>
              <a:ext cx="2403890" cy="276999"/>
              <a:chOff x="502080" y="5714555"/>
              <a:chExt cx="2403890" cy="276999"/>
            </a:xfrm>
          </p:grpSpPr>
          <p:sp>
            <p:nvSpPr>
              <p:cNvPr id="13" name="Rectangle 12">
                <a:extLst>
                  <a:ext uri="{FF2B5EF4-FFF2-40B4-BE49-F238E27FC236}">
                    <a16:creationId xmlns:a16="http://schemas.microsoft.com/office/drawing/2014/main" id="{2FF202B9-E7AA-8854-2D88-2F147C29E112}"/>
                  </a:ext>
                </a:extLst>
              </p:cNvPr>
              <p:cNvSpPr/>
              <p:nvPr/>
            </p:nvSpPr>
            <p:spPr>
              <a:xfrm>
                <a:off x="2249987" y="5828206"/>
                <a:ext cx="655983" cy="49696"/>
              </a:xfrm>
              <a:prstGeom prst="rect">
                <a:avLst/>
              </a:prstGeom>
              <a:solidFill>
                <a:srgbClr val="DBD49C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" name="ZoneTexte 18">
                <a:extLst>
                  <a:ext uri="{FF2B5EF4-FFF2-40B4-BE49-F238E27FC236}">
                    <a16:creationId xmlns:a16="http://schemas.microsoft.com/office/drawing/2014/main" id="{69D0B974-7354-DA0C-7935-F4ADD3179DB0}"/>
                  </a:ext>
                </a:extLst>
              </p:cNvPr>
              <p:cNvSpPr txBox="1"/>
              <p:nvPr/>
            </p:nvSpPr>
            <p:spPr>
              <a:xfrm>
                <a:off x="502080" y="5714555"/>
                <a:ext cx="16772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Shared protein domains</a:t>
                </a:r>
              </a:p>
            </p:txBody>
          </p:sp>
        </p:grpSp>
        <p:grpSp>
          <p:nvGrpSpPr>
            <p:cNvPr id="27" name="Groupe 26">
              <a:extLst>
                <a:ext uri="{FF2B5EF4-FFF2-40B4-BE49-F238E27FC236}">
                  <a16:creationId xmlns:a16="http://schemas.microsoft.com/office/drawing/2014/main" id="{C589EC8F-0E1A-C654-75A5-BC64128E119A}"/>
                </a:ext>
              </a:extLst>
            </p:cNvPr>
            <p:cNvGrpSpPr/>
            <p:nvPr/>
          </p:nvGrpSpPr>
          <p:grpSpPr>
            <a:xfrm>
              <a:off x="786580" y="6183770"/>
              <a:ext cx="2122784" cy="276999"/>
              <a:chOff x="786580" y="6177312"/>
              <a:chExt cx="2122784" cy="276999"/>
            </a:xfrm>
          </p:grpSpPr>
          <p:sp>
            <p:nvSpPr>
              <p:cNvPr id="11" name="Rectangle 10">
                <a:extLst>
                  <a:ext uri="{FF2B5EF4-FFF2-40B4-BE49-F238E27FC236}">
                    <a16:creationId xmlns:a16="http://schemas.microsoft.com/office/drawing/2014/main" id="{248CA112-AE56-327F-A713-1D5C073E20E6}"/>
                  </a:ext>
                </a:extLst>
              </p:cNvPr>
              <p:cNvSpPr/>
              <p:nvPr/>
            </p:nvSpPr>
            <p:spPr>
              <a:xfrm>
                <a:off x="2253381" y="6290963"/>
                <a:ext cx="655983" cy="49696"/>
              </a:xfrm>
              <a:prstGeom prst="rect">
                <a:avLst/>
              </a:prstGeom>
              <a:solidFill>
                <a:srgbClr val="FD9E8A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" name="ZoneTexte 19">
                <a:extLst>
                  <a:ext uri="{FF2B5EF4-FFF2-40B4-BE49-F238E27FC236}">
                    <a16:creationId xmlns:a16="http://schemas.microsoft.com/office/drawing/2014/main" id="{674137F7-97C6-AE6C-FD89-A0174C0E1261}"/>
                  </a:ext>
                </a:extLst>
              </p:cNvPr>
              <p:cNvSpPr txBox="1"/>
              <p:nvPr/>
            </p:nvSpPr>
            <p:spPr>
              <a:xfrm>
                <a:off x="786580" y="6177312"/>
                <a:ext cx="13927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Physical interaction</a:t>
                </a:r>
              </a:p>
            </p:txBody>
          </p:sp>
        </p:grpSp>
        <p:grpSp>
          <p:nvGrpSpPr>
            <p:cNvPr id="28" name="Groupe 27">
              <a:extLst>
                <a:ext uri="{FF2B5EF4-FFF2-40B4-BE49-F238E27FC236}">
                  <a16:creationId xmlns:a16="http://schemas.microsoft.com/office/drawing/2014/main" id="{8AAA7A97-F706-F7C0-320A-177349ABC806}"/>
                </a:ext>
              </a:extLst>
            </p:cNvPr>
            <p:cNvGrpSpPr/>
            <p:nvPr/>
          </p:nvGrpSpPr>
          <p:grpSpPr>
            <a:xfrm>
              <a:off x="797866" y="6332184"/>
              <a:ext cx="2113195" cy="276999"/>
              <a:chOff x="797866" y="6429619"/>
              <a:chExt cx="2113195" cy="276999"/>
            </a:xfrm>
          </p:grpSpPr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id="{6D34C78A-1848-D24D-42E0-926B8C3D8EA9}"/>
                  </a:ext>
                </a:extLst>
              </p:cNvPr>
              <p:cNvSpPr/>
              <p:nvPr/>
            </p:nvSpPr>
            <p:spPr>
              <a:xfrm>
                <a:off x="2255078" y="6543270"/>
                <a:ext cx="655983" cy="49696"/>
              </a:xfrm>
              <a:prstGeom prst="rect">
                <a:avLst/>
              </a:prstGeom>
              <a:solidFill>
                <a:srgbClr val="97C3E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" name="ZoneTexte 20">
                <a:extLst>
                  <a:ext uri="{FF2B5EF4-FFF2-40B4-BE49-F238E27FC236}">
                    <a16:creationId xmlns:a16="http://schemas.microsoft.com/office/drawing/2014/main" id="{0727A6C5-2E4A-B458-D1C5-A0391C2F1AEB}"/>
                  </a:ext>
                </a:extLst>
              </p:cNvPr>
              <p:cNvSpPr txBox="1"/>
              <p:nvPr/>
            </p:nvSpPr>
            <p:spPr>
              <a:xfrm>
                <a:off x="797866" y="6429619"/>
                <a:ext cx="138146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Genetic interaction</a:t>
                </a:r>
              </a:p>
            </p:txBody>
          </p:sp>
        </p:grpSp>
        <p:grpSp>
          <p:nvGrpSpPr>
            <p:cNvPr id="26" name="Groupe 25">
              <a:extLst>
                <a:ext uri="{FF2B5EF4-FFF2-40B4-BE49-F238E27FC236}">
                  <a16:creationId xmlns:a16="http://schemas.microsoft.com/office/drawing/2014/main" id="{E482C497-6C12-006A-EFDC-135B09D86F60}"/>
                </a:ext>
              </a:extLst>
            </p:cNvPr>
            <p:cNvGrpSpPr/>
            <p:nvPr/>
          </p:nvGrpSpPr>
          <p:grpSpPr>
            <a:xfrm>
              <a:off x="1115773" y="6035355"/>
              <a:ext cx="1791894" cy="276999"/>
              <a:chOff x="1115773" y="5911251"/>
              <a:chExt cx="1791894" cy="276999"/>
            </a:xfrm>
          </p:grpSpPr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id="{D971E38E-C87B-E9BD-7C61-9E89204006F5}"/>
                  </a:ext>
                </a:extLst>
              </p:cNvPr>
              <p:cNvSpPr/>
              <p:nvPr/>
            </p:nvSpPr>
            <p:spPr>
              <a:xfrm>
                <a:off x="2251684" y="6024902"/>
                <a:ext cx="655983" cy="49696"/>
              </a:xfrm>
              <a:prstGeom prst="rect">
                <a:avLst/>
              </a:prstGeom>
              <a:solidFill>
                <a:srgbClr val="D5B6D7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" name="ZoneTexte 21">
                <a:extLst>
                  <a:ext uri="{FF2B5EF4-FFF2-40B4-BE49-F238E27FC236}">
                    <a16:creationId xmlns:a16="http://schemas.microsoft.com/office/drawing/2014/main" id="{44C7ADD0-A487-1C38-CC2E-29BBB6EB192B}"/>
                  </a:ext>
                </a:extLst>
              </p:cNvPr>
              <p:cNvSpPr txBox="1"/>
              <p:nvPr/>
            </p:nvSpPr>
            <p:spPr>
              <a:xfrm>
                <a:off x="1115773" y="5911251"/>
                <a:ext cx="106356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Co-expression</a:t>
                </a:r>
              </a:p>
            </p:txBody>
          </p:sp>
        </p:grpSp>
      </p:grpSp>
      <p:pic>
        <p:nvPicPr>
          <p:cNvPr id="3" name="Image 2">
            <a:extLst>
              <a:ext uri="{FF2B5EF4-FFF2-40B4-BE49-F238E27FC236}">
                <a16:creationId xmlns:a16="http://schemas.microsoft.com/office/drawing/2014/main" id="{74815FE1-EC74-19FD-6AE7-50E50208033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185" t="2849" r="20612" b="6091"/>
          <a:stretch/>
        </p:blipFill>
        <p:spPr>
          <a:xfrm>
            <a:off x="1652638" y="213150"/>
            <a:ext cx="6475362" cy="53213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947092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ésentation5" id="{5E054263-DD83-3D47-8BBF-600FC9C2D858}" vid="{8D00A492-C65F-5047-8239-F5A7110D55A7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Thème Office</Template>
  <TotalTime>65</TotalTime>
  <Words>17</Words>
  <Application>Microsoft Macintosh PowerPoint</Application>
  <PresentationFormat>Format A4 (210 x 297 mm)</PresentationFormat>
  <Paragraphs>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-webkit-standard</vt:lpstr>
      <vt:lpstr>Arial</vt:lpstr>
      <vt:lpstr>Calibri</vt:lpstr>
      <vt:lpstr>Calibri Light</vt:lpstr>
      <vt:lpstr>Thème Office</vt:lpstr>
      <vt:lpstr>Présentation PowerPoint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Marc Muller</dc:creator>
  <cp:keywords/>
  <dc:description/>
  <cp:lastModifiedBy>Marc Muller</cp:lastModifiedBy>
  <cp:revision>1</cp:revision>
  <dcterms:created xsi:type="dcterms:W3CDTF">2023-05-04T09:29:02Z</dcterms:created>
  <dcterms:modified xsi:type="dcterms:W3CDTF">2023-05-28T09:18:01Z</dcterms:modified>
  <cp:category/>
</cp:coreProperties>
</file>